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46875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9AFAC-E300-4F06-AE62-BD4B36F07C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969FF-922E-4039-900A-097BEDFDFF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7C4FE-06E3-43CC-9741-9C570AC99A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159B26-E5B5-48FF-BE3D-A8ED83A69C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91B404-CCF7-4336-8C6D-1B6CC07B0A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AB2DC-584F-4DC2-94EC-4F1F705936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CE86A7-77FB-492D-AED2-84A2AA2397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8D8C4F-8452-4742-B50E-0121E6E731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5D576A-D59A-4C14-867A-3FC51B02AB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9B689-94E4-499F-A4D0-A09A3A0C25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0045D-D36B-42F3-A684-008D8BA39B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29D71-C82D-49C3-8097-F9435AAA8B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ABD8B7-BBCD-41FB-AF32-D5135629E29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wmf"/><Relationship Id="rId4" Type="http://schemas.openxmlformats.org/officeDocument/2006/relationships/image" Target="../media/image3.wmf"/><Relationship Id="rId5" Type="http://schemas.openxmlformats.org/officeDocument/2006/relationships/image" Target="../media/image4.wmf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23960" y="534960"/>
          <a:ext cx="4081320" cy="27860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23960" y="534960"/>
                    <a:ext cx="4081320" cy="2786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5087880" y="571680"/>
            <a:ext cx="3668760" cy="26953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030320" y="2351160"/>
            <a:ext cx="195120" cy="2365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081080" y="4149720"/>
            <a:ext cx="1473120" cy="18651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356080" y="2394000"/>
            <a:ext cx="195480" cy="2365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795760" y="4140360"/>
            <a:ext cx="1473120" cy="18745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042920" y="256536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76480" y="3000240"/>
            <a:ext cx="598320" cy="11401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3506760" y="2946240"/>
            <a:ext cx="1998720" cy="11890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"/>
          <p:cNvGrpSpPr/>
          <p:nvPr/>
        </p:nvGrpSpPr>
        <p:grpSpPr>
          <a:xfrm>
            <a:off x="971640" y="4089240"/>
            <a:ext cx="1604880" cy="1876680"/>
            <a:chOff x="971640" y="4089240"/>
            <a:chExt cx="1604880" cy="1876680"/>
          </a:xfrm>
        </p:grpSpPr>
        <p:pic>
          <p:nvPicPr>
            <p:cNvPr id="52" name="" descr=""/>
            <p:cNvPicPr/>
            <p:nvPr/>
          </p:nvPicPr>
          <p:blipFill>
            <a:blip r:embed="rId4"/>
            <a:stretch/>
          </p:blipFill>
          <p:spPr>
            <a:xfrm>
              <a:off x="971640" y="4089240"/>
              <a:ext cx="1604880" cy="1876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>
              <a:off x="1346400" y="5715000"/>
              <a:ext cx="1003320" cy="6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3040" bIns="23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"/>
          <p:cNvGrpSpPr/>
          <p:nvPr/>
        </p:nvGrpSpPr>
        <p:grpSpPr>
          <a:xfrm>
            <a:off x="2719440" y="4076640"/>
            <a:ext cx="1533600" cy="1866960"/>
            <a:chOff x="2719440" y="4076640"/>
            <a:chExt cx="1533600" cy="1866960"/>
          </a:xfrm>
        </p:grpSpPr>
        <p:pic>
          <p:nvPicPr>
            <p:cNvPr id="55" name="" descr=""/>
            <p:cNvPicPr/>
            <p:nvPr/>
          </p:nvPicPr>
          <p:blipFill>
            <a:blip r:embed="rId5"/>
            <a:stretch/>
          </p:blipFill>
          <p:spPr>
            <a:xfrm>
              <a:off x="2719440" y="4076640"/>
              <a:ext cx="1533600" cy="1866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"/>
            <p:cNvSpPr/>
            <p:nvPr/>
          </p:nvSpPr>
          <p:spPr>
            <a:xfrm>
              <a:off x="3035520" y="5683320"/>
              <a:ext cx="1003320" cy="6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3040" bIns="23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"/>
          <p:cNvGrpSpPr/>
          <p:nvPr/>
        </p:nvGrpSpPr>
        <p:grpSpPr>
          <a:xfrm>
            <a:off x="1272600" y="5659560"/>
            <a:ext cx="1260000" cy="302760"/>
            <a:chOff x="1272600" y="5659560"/>
            <a:chExt cx="1260000" cy="302760"/>
          </a:xfrm>
        </p:grpSpPr>
        <p:sp>
          <p:nvSpPr>
            <p:cNvPr id="58" name=""/>
            <p:cNvSpPr/>
            <p:nvPr/>
          </p:nvSpPr>
          <p:spPr>
            <a:xfrm>
              <a:off x="1272600" y="5661000"/>
              <a:ext cx="42444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627560" y="5659560"/>
              <a:ext cx="51768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F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ps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014920" y="5659560"/>
              <a:ext cx="51768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F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gs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" name=""/>
          <p:cNvGrpSpPr/>
          <p:nvPr/>
        </p:nvGrpSpPr>
        <p:grpSpPr>
          <a:xfrm>
            <a:off x="2979360" y="5661000"/>
            <a:ext cx="1260000" cy="302760"/>
            <a:chOff x="2979360" y="5661000"/>
            <a:chExt cx="1260000" cy="302760"/>
          </a:xfrm>
        </p:grpSpPr>
        <p:sp>
          <p:nvSpPr>
            <p:cNvPr id="62" name=""/>
            <p:cNvSpPr/>
            <p:nvPr/>
          </p:nvSpPr>
          <p:spPr>
            <a:xfrm>
              <a:off x="2979360" y="5662440"/>
              <a:ext cx="42444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334320" y="5661000"/>
              <a:ext cx="51768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F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ps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721680" y="5661000"/>
              <a:ext cx="51768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F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gs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"/>
          <p:cNvSpPr/>
          <p:nvPr/>
        </p:nvSpPr>
        <p:spPr>
          <a:xfrm>
            <a:off x="2187000" y="347760"/>
            <a:ext cx="114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6 speci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479640" y="372960"/>
            <a:ext cx="114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5 speci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95640" y="137628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70080" y="614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789800" y="6206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97080" y="3638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"/>
          <p:cNvGrpSpPr/>
          <p:nvPr/>
        </p:nvGrpSpPr>
        <p:grpSpPr>
          <a:xfrm>
            <a:off x="5722920" y="4255920"/>
            <a:ext cx="2520720" cy="1728720"/>
            <a:chOff x="5722920" y="4255920"/>
            <a:chExt cx="2520720" cy="1728720"/>
          </a:xfrm>
        </p:grpSpPr>
        <p:sp>
          <p:nvSpPr>
            <p:cNvPr id="72" name=""/>
            <p:cNvSpPr/>
            <p:nvPr/>
          </p:nvSpPr>
          <p:spPr>
            <a:xfrm>
              <a:off x="5833080" y="4400280"/>
              <a:ext cx="231120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ps6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= 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6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/ (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6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+F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ps6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) = 99.9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826960" y="4678200"/>
              <a:ext cx="231120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ps5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= 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5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/ (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5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+F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ps5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) = 99.7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820480" y="5117760"/>
              <a:ext cx="231120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gs6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= 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6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/ (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6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+F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gs6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) = 93.3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820480" y="5408280"/>
              <a:ext cx="231120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gs5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= 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5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/ (T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5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+FP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Arial"/>
                </a:rPr>
                <a:t>gs5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) = 85.1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722920" y="4255920"/>
              <a:ext cx="2520720" cy="1728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7" name=""/>
          <p:cNvSpPr/>
          <p:nvPr/>
        </p:nvSpPr>
        <p:spPr>
          <a:xfrm>
            <a:off x="5947200" y="3789360"/>
            <a:ext cx="214488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Precision (P</a:t>
            </a:r>
            <a:r>
              <a:rPr b="0" lang="en-GB" sz="1800" spc="-1" strike="noStrike" baseline="-25000">
                <a:solidFill>
                  <a:srgbClr val="000000"/>
                </a:solidFill>
                <a:latin typeface="Arial"/>
              </a:rPr>
              <a:t>ps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&amp;</a:t>
            </a:r>
            <a:r>
              <a:rPr b="0" lang="en-GB" sz="1800" spc="-1" strike="noStrike" baseline="-25000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GB" sz="1800" spc="-1" strike="noStrike" baseline="-25000">
                <a:solidFill>
                  <a:srgbClr val="000000"/>
                </a:solidFill>
                <a:latin typeface="Arial"/>
              </a:rPr>
              <a:t>gs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775400" y="3645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207600" y="630864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806480" y="3159000"/>
            <a:ext cx="1922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Euclidean distance bi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6188040" y="3159000"/>
            <a:ext cx="1922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Euclidean distance bi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2" name=""/>
          <p:cNvGrpSpPr/>
          <p:nvPr/>
        </p:nvGrpSpPr>
        <p:grpSpPr>
          <a:xfrm>
            <a:off x="2470320" y="836640"/>
            <a:ext cx="1812960" cy="276480"/>
            <a:chOff x="2470320" y="836640"/>
            <a:chExt cx="1812960" cy="276480"/>
          </a:xfrm>
        </p:grpSpPr>
        <p:sp>
          <p:nvSpPr>
            <p:cNvPr id="83" name=""/>
            <p:cNvSpPr/>
            <p:nvPr/>
          </p:nvSpPr>
          <p:spPr>
            <a:xfrm>
              <a:off x="3848040" y="922320"/>
              <a:ext cx="98640" cy="1033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470320" y="922320"/>
              <a:ext cx="98280" cy="103320"/>
            </a:xfrm>
            <a:prstGeom prst="rect">
              <a:avLst/>
            </a:prstGeom>
            <a:solidFill>
              <a:srgbClr val="0028f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255840" y="922320"/>
              <a:ext cx="98640" cy="103320"/>
            </a:xfrm>
            <a:prstGeom prst="rect">
              <a:avLst/>
            </a:prstGeom>
            <a:solidFill>
              <a:srgbClr val="d698b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898440" y="836640"/>
              <a:ext cx="38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308400" y="83664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G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527560" y="836640"/>
              <a:ext cx="49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Re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"/>
          <p:cNvGrpSpPr/>
          <p:nvPr/>
        </p:nvGrpSpPr>
        <p:grpSpPr>
          <a:xfrm>
            <a:off x="6861240" y="851040"/>
            <a:ext cx="1812960" cy="276480"/>
            <a:chOff x="6861240" y="851040"/>
            <a:chExt cx="1812960" cy="276480"/>
          </a:xfrm>
        </p:grpSpPr>
        <p:sp>
          <p:nvSpPr>
            <p:cNvPr id="90" name=""/>
            <p:cNvSpPr/>
            <p:nvPr/>
          </p:nvSpPr>
          <p:spPr>
            <a:xfrm>
              <a:off x="8238960" y="936360"/>
              <a:ext cx="98640" cy="1029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6861240" y="936360"/>
              <a:ext cx="98280" cy="102960"/>
            </a:xfrm>
            <a:prstGeom prst="rect">
              <a:avLst/>
            </a:prstGeom>
            <a:solidFill>
              <a:srgbClr val="0028f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7646760" y="936360"/>
              <a:ext cx="98640" cy="102960"/>
            </a:xfrm>
            <a:prstGeom prst="rect">
              <a:avLst/>
            </a:prstGeom>
            <a:solidFill>
              <a:srgbClr val="d698b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8289360" y="851040"/>
              <a:ext cx="38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7699320" y="85104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G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6918480" y="851040"/>
              <a:ext cx="49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Re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01T14:26:28Z</dcterms:created>
  <dc:creator>ucbcja0</dc:creator>
  <dc:description/>
  <dc:language>en-US</dc:language>
  <cp:lastModifiedBy>ucbcja0</cp:lastModifiedBy>
  <dcterms:modified xsi:type="dcterms:W3CDTF">2007-06-08T15:02:59Z</dcterms:modified>
  <cp:revision>25</cp:revision>
  <dc:subject/>
  <dc:title>Slide 1</dc:title>
</cp:coreProperties>
</file>